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712" autoAdjust="0"/>
    <p:restoredTop sz="86667"/>
  </p:normalViewPr>
  <p:slideViewPr>
    <p:cSldViewPr snapToGrid="0">
      <p:cViewPr varScale="1">
        <p:scale>
          <a:sx n="110" d="100"/>
          <a:sy n="110" d="100"/>
        </p:scale>
        <p:origin x="16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CFE6AB-B46B-9142-A659-DB1F46C49D0B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63629A-18D9-FB4C-B2BB-8AA7C73519E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23460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Accession mean disease score in y axis label panel a. You can just put mean disease score as label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F63629A-18D9-FB4C-B2BB-8AA7C73519E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09010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C8A314-D0CC-484D-8467-689EF33CBE0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8B0859A-9692-4EEA-81C2-E35956312C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B5BE9D-17D8-4A7F-88EC-1C9A141D1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C7280-87E5-4C49-B9DF-9CD3E4AF5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11F713-AFB4-4EE0-A98D-F1E61BCEC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9FDB02-F581-455C-A071-62DD086C5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6D9-655E-4FAD-9344-CE3174776D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5658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C68802-39ED-486C-BC16-3844E992E7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72BD1C-A7E4-4624-9856-7A76D605C6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32133A-649E-42FB-943E-B57D8C06FF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C7280-87E5-4C49-B9DF-9CD3E4AF5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6C2FA9-E9D7-434D-BC21-05E2D3F824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23C258-F7CF-467B-8328-27369DA7C9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6D9-655E-4FAD-9344-CE3174776D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4332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F8DDDD2-79F9-4082-B4FA-CAC6B2EC21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7E1095-FC0B-4EA0-AC4B-BA6CB75572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5EF327-DB33-445E-9D05-9A87CD1A2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C7280-87E5-4C49-B9DF-9CD3E4AF5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9B7A13-DFB2-47A8-9423-B6986E822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0F0E0C-CB45-4EA7-951E-288A25850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6D9-655E-4FAD-9344-CE3174776D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1471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19132B-60BA-4BBF-80BB-2CC34D7448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36E6BF-CD9B-4CB8-A17A-8142ABCA1D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BBC0C9-8F60-4214-9759-4E6D8EEE58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C7280-87E5-4C49-B9DF-9CD3E4AF5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E665DE-2AC4-4485-9146-CAB9FBBED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122DCB-7B41-41F9-B901-2BC8B4DBB9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6D9-655E-4FAD-9344-CE3174776D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8887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A39593-5063-4B0F-A85E-805A5D5B93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339FE0-8585-42E5-B575-87A27250CF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2DA482-17ED-4A67-ADC3-7BDDB3A142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C7280-87E5-4C49-B9DF-9CD3E4AF5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DAED35-F707-4B00-B34B-FE1F6AD4F7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052F30-719D-4243-B0A1-71B600AC4A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6D9-655E-4FAD-9344-CE3174776D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3636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8B3E20-2614-4A33-A32F-27B97D25FC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11C5F54-5AA2-4DE4-968D-FEE7D21FA7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BB8FA7-F8D2-4DA6-9BCA-EA2DB22023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0A0F0E-EB0C-48DD-8DFD-C055C9A0D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C7280-87E5-4C49-B9DF-9CD3E4AF5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2D2F35-93F5-44B6-9575-E0DBDC2950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B5EC0B-ACBD-40B2-943F-9BE178AC57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6D9-655E-4FAD-9344-CE3174776D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568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470440-4C50-4D63-A1E5-73F70DB398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B4FF85-B1B6-4706-9579-DD779723D0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7B06DC-D0B3-4231-9A0A-F18E22081A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9D3F202-33B1-4116-A448-C8D766448F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A87A55D-C78F-4A68-BC79-B01D0557E4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976F667-316B-4C90-9311-45E1701D1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C7280-87E5-4C49-B9DF-9CD3E4AF5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6F204D1-2BC1-4892-9315-CE2CB73E3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E4A0C8C-9D43-4EBB-A098-B97D06695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6D9-655E-4FAD-9344-CE3174776D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23881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41EBC5-A808-4791-B67B-84510AFB49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1651A7C-5851-43E4-87E1-A159B0CB48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C7280-87E5-4C49-B9DF-9CD3E4AF5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60AE4F9-4F09-47E0-9F8B-2F1B67479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6B73FAD-F9C8-4140-A883-397239B74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6D9-655E-4FAD-9344-CE3174776D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2873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C61979-4C74-45DC-8470-97A5581FB2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C7280-87E5-4C49-B9DF-9CD3E4AF5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3F85FD7-36E0-4EAB-B4AD-14F6306F1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84630E3-3AFB-4F23-97CB-A19403FF73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6D9-655E-4FAD-9344-CE3174776D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4195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926EFF-71FE-4F58-A399-E57F2796E4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1C5FFA-E3CF-4DCC-B0DA-18D3BD2642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3367BAF-9001-4E8E-992D-A7DB0745D3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82DCA0-DBF5-4E42-9E09-4DC31B0E2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C7280-87E5-4C49-B9DF-9CD3E4AF5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1CEA79-E04D-4A98-9BA4-5B518B1B2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14E7F9-BA38-4CC4-A2C3-FD604CD92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6D9-655E-4FAD-9344-CE3174776D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36222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B69E16-54A9-4E18-A5C8-343A452FCE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D403528-276B-4398-8AEF-F2D394260A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040328-6D03-4EC3-8F76-F1C0B71ACC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25B256-1C76-40B4-9E94-9F8B281B81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C7280-87E5-4C49-B9DF-9CD3E4AF5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524A4F-60C4-406F-88AF-8C514430B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584F12-E62A-4139-BDC3-1F12E5672B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9E6D9-655E-4FAD-9344-CE3174776D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20758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7D79FC-7BBB-4FF5-9726-72A32916D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182C07-B1E8-4E3B-A887-B851DA9D5C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FFD79B-5BE0-4B26-8133-4D0B7E6F11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C7280-87E5-4C49-B9DF-9CD3E4AF5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428DD3-31DC-4862-A8D2-60004E2468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7CC849-570A-4D56-B7C8-CE0E2B51DA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E9E6D9-655E-4FAD-9344-CE3174776D0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2416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F694236-12A7-492C-B317-EEB75672E53B}"/>
              </a:ext>
            </a:extLst>
          </p:cNvPr>
          <p:cNvSpPr txBox="1"/>
          <p:nvPr/>
        </p:nvSpPr>
        <p:spPr>
          <a:xfrm>
            <a:off x="1601571" y="5658646"/>
            <a:ext cx="812387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3: </a:t>
            </a:r>
            <a:r>
              <a:rPr lang="en-US" sz="1200" dirty="0"/>
              <a:t>Whole Plant Disease incidence scoring on seven lettuce accessions. All accessions are </a:t>
            </a:r>
            <a:r>
              <a:rPr lang="en-US" sz="1200" i="1" dirty="0"/>
              <a:t>L. sativa </a:t>
            </a:r>
            <a:r>
              <a:rPr lang="en-US" sz="1200" dirty="0"/>
              <a:t>unless otherwise indicated. (A) Mean disease symptom scoring out of 4 for each lettuce accession from 14 to 49 days post treatment in response to </a:t>
            </a:r>
            <a:r>
              <a:rPr lang="en-US" sz="1200" i="1" dirty="0"/>
              <a:t>B. cinerea</a:t>
            </a:r>
            <a:r>
              <a:rPr lang="en-US" sz="1200" dirty="0"/>
              <a:t> and </a:t>
            </a:r>
            <a:r>
              <a:rPr lang="en-US" sz="1200" i="1" dirty="0"/>
              <a:t>S. </a:t>
            </a:r>
            <a:r>
              <a:rPr lang="en-US" sz="1200" i="1" dirty="0" err="1"/>
              <a:t>sclerotiorum</a:t>
            </a:r>
            <a:r>
              <a:rPr lang="en-US" sz="1200" dirty="0"/>
              <a:t>. Error bars are standard error, n=18.  (B) Area under the disease progression curve (AUDPC) calculated to </a:t>
            </a:r>
            <a:r>
              <a:rPr lang="en-US" sz="1200" dirty="0" err="1"/>
              <a:t>summarise</a:t>
            </a:r>
            <a:r>
              <a:rPr lang="en-US" sz="1200" dirty="0"/>
              <a:t> disease progression over time for each individual plant, n=18. Letters represent Tukey HSD statistical significance groupings (p&lt;0.05).  </a:t>
            </a:r>
            <a:endParaRPr lang="en-GB" sz="12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E28C28E-02F2-4293-A5C6-874D6C12C3F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7634" y="183691"/>
            <a:ext cx="9813817" cy="53529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62844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127</Words>
  <Application>Microsoft Macintosh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y Pink</dc:creator>
  <cp:lastModifiedBy>Katherine Denby</cp:lastModifiedBy>
  <cp:revision>10</cp:revision>
  <dcterms:created xsi:type="dcterms:W3CDTF">2021-04-11T17:08:47Z</dcterms:created>
  <dcterms:modified xsi:type="dcterms:W3CDTF">2022-02-20T15:33:51Z</dcterms:modified>
</cp:coreProperties>
</file>